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60A17-8AD2-41CE-B903-1052B48F04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38B1FF-E8D1-4B94-A7A6-760D2F1ECE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C996A1-C233-46C2-B194-043D77D923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F98CA2-3E57-4BB2-93FF-D1F5C1ADBB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B5D50-4A79-4CFB-9D78-2A90448554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8C43B6-20D5-449B-A060-B906605976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0EF4CF-9A7F-4F64-9605-C47B168EC8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1AD19-9AE3-4493-82B2-50D21D3B76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AE7574-8814-4E54-8EEE-AB5DDBAB3F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351D5-B666-459C-BEE5-3DCE6982B8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9DD72-6949-4AA6-8EC6-B85E06C903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BCDFA-C928-4F76-92F5-53B848FBDC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2568D0-B2D3-4FE7-B1BD-A6E15B85825F}" type="slidenum"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557360" y="2670120"/>
            <a:ext cx="0" cy="2305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 rot="16200000">
            <a:off x="1104120" y="4180680"/>
            <a:ext cx="66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7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1113480" y="3043440"/>
            <a:ext cx="66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3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806400" y="3648960"/>
            <a:ext cx="102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EBV infe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1146600" y="1865520"/>
            <a:ext cx="66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7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757800" y="1905120"/>
            <a:ext cx="1155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Mock infe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-45000" y="1584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新細明體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389240" y="3392640"/>
            <a:ext cx="0" cy="790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02320" y="830160"/>
            <a:ext cx="256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EBV infection/primary B cells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090880" y="126360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DAP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424320" y="1263600"/>
            <a:ext cx="114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EBNA2/FI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827600" y="1258920"/>
            <a:ext cx="138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NPM1/Roda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915840" y="7794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"/>
          <p:cNvGraphicFramePr/>
          <p:nvPr/>
        </p:nvGraphicFramePr>
        <p:xfrm>
          <a:off x="1573200" y="1512720"/>
          <a:ext cx="4606920" cy="34592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73200" y="1512720"/>
                    <a:ext cx="4606920" cy="3459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-45000" y="1584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新細明體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090880" y="126360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DAP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424320" y="1263600"/>
            <a:ext cx="114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EBNA2/FI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815000" y="1258920"/>
            <a:ext cx="138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c-myc/Roda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752400" y="3659040"/>
            <a:ext cx="102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EBV infe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16200000">
            <a:off x="1081800" y="4191120"/>
            <a:ext cx="66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7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1082160" y="3039120"/>
            <a:ext cx="66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3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521000" y="2635200"/>
            <a:ext cx="0" cy="2232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515960" y="6026040"/>
            <a:ext cx="0" cy="2232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743040" y="7116120"/>
            <a:ext cx="102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EBV infe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6200000">
            <a:off x="1081800" y="7642440"/>
            <a:ext cx="66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7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1082160" y="6483960"/>
            <a:ext cx="66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3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1101240" y="1937520"/>
            <a:ext cx="66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7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712080" y="1988280"/>
            <a:ext cx="11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Mock infe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6200000">
            <a:off x="1117080" y="5226840"/>
            <a:ext cx="660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7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699480" y="5277600"/>
            <a:ext cx="11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Mock infe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344600" y="3367080"/>
            <a:ext cx="0" cy="863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344600" y="6819840"/>
            <a:ext cx="0" cy="863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915840" y="7794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102320" y="830160"/>
            <a:ext cx="256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EBV infection/primary B cells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6" name=""/>
          <p:cNvGraphicFramePr/>
          <p:nvPr/>
        </p:nvGraphicFramePr>
        <p:xfrm>
          <a:off x="1547640" y="1495440"/>
          <a:ext cx="4491360" cy="67690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47640" y="1495440"/>
                    <a:ext cx="4491360" cy="6769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"/>
          <p:cNvSpPr/>
          <p:nvPr/>
        </p:nvSpPr>
        <p:spPr>
          <a:xfrm>
            <a:off x="-45000" y="1584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新細明體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920520" y="6112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"/>
          <p:cNvGrpSpPr/>
          <p:nvPr/>
        </p:nvGrpSpPr>
        <p:grpSpPr>
          <a:xfrm>
            <a:off x="1344600" y="1225080"/>
            <a:ext cx="3924360" cy="2223000"/>
            <a:chOff x="1344600" y="1225080"/>
            <a:chExt cx="3924360" cy="2223000"/>
          </a:xfrm>
        </p:grpSpPr>
        <p:sp>
          <p:nvSpPr>
            <p:cNvPr id="81" name=""/>
            <p:cNvSpPr/>
            <p:nvPr/>
          </p:nvSpPr>
          <p:spPr>
            <a:xfrm>
              <a:off x="1785960" y="1303200"/>
              <a:ext cx="64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DAP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660760" y="1303200"/>
              <a:ext cx="64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EBNA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595680" y="1325520"/>
              <a:ext cx="64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NPM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84" name=""/>
            <p:cNvGraphicFramePr/>
            <p:nvPr/>
          </p:nvGraphicFramePr>
          <p:xfrm>
            <a:off x="1554120" y="1512720"/>
            <a:ext cx="3714840" cy="9590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85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554120" y="1512720"/>
                      <a:ext cx="3714840" cy="959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6" name=""/>
            <p:cNvGraphicFramePr/>
            <p:nvPr/>
          </p:nvGraphicFramePr>
          <p:xfrm>
            <a:off x="1554120" y="2482920"/>
            <a:ext cx="3714840" cy="96516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87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554120" y="2482920"/>
                      <a:ext cx="3714840" cy="965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8" name=""/>
            <p:cNvSpPr/>
            <p:nvPr/>
          </p:nvSpPr>
          <p:spPr>
            <a:xfrm>
              <a:off x="4500720" y="1312920"/>
              <a:ext cx="64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Merg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6200000">
              <a:off x="889560" y="2656080"/>
              <a:ext cx="115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Primary 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6200000">
              <a:off x="898920" y="1679760"/>
              <a:ext cx="115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LCL-Ne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1" name=""/>
          <p:cNvSpPr/>
          <p:nvPr/>
        </p:nvSpPr>
        <p:spPr>
          <a:xfrm>
            <a:off x="1156320" y="671400"/>
            <a:ext cx="4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LC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0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3T07:43:06Z</dcterms:created>
  <dc:creator>User</dc:creator>
  <dc:description/>
  <dc:language>en-US</dc:language>
  <cp:lastModifiedBy>MC SYSTEM</cp:lastModifiedBy>
  <dcterms:modified xsi:type="dcterms:W3CDTF">2012-11-13T00:39:15Z</dcterms:modified>
  <cp:revision>1646</cp:revision>
  <dc:subject/>
  <dc:title>投影片 1</dc:title>
</cp:coreProperties>
</file>